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762" y="-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6BE26-DBFF-4419-BFBB-3FA469EE19A6}" type="datetimeFigureOut">
              <a:rPr lang="en-AU" smtClean="0"/>
              <a:pPr/>
              <a:t>26/03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F3ED-2CCA-455B-9831-C8993F948832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560285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6BE26-DBFF-4419-BFBB-3FA469EE19A6}" type="datetimeFigureOut">
              <a:rPr lang="en-AU" smtClean="0"/>
              <a:pPr/>
              <a:t>26/03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F3ED-2CCA-455B-9831-C8993F948832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39109948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6BE26-DBFF-4419-BFBB-3FA469EE19A6}" type="datetimeFigureOut">
              <a:rPr lang="en-AU" smtClean="0"/>
              <a:pPr/>
              <a:t>26/03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F3ED-2CCA-455B-9831-C8993F948832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4768087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6BE26-DBFF-4419-BFBB-3FA469EE19A6}" type="datetimeFigureOut">
              <a:rPr lang="en-AU" smtClean="0"/>
              <a:pPr/>
              <a:t>26/03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F3ED-2CCA-455B-9831-C8993F948832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15486391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6BE26-DBFF-4419-BFBB-3FA469EE19A6}" type="datetimeFigureOut">
              <a:rPr lang="en-AU" smtClean="0"/>
              <a:pPr/>
              <a:t>26/03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F3ED-2CCA-455B-9831-C8993F948832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6989129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6BE26-DBFF-4419-BFBB-3FA469EE19A6}" type="datetimeFigureOut">
              <a:rPr lang="en-AU" smtClean="0"/>
              <a:pPr/>
              <a:t>26/03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F3ED-2CCA-455B-9831-C8993F948832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6547283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6BE26-DBFF-4419-BFBB-3FA469EE19A6}" type="datetimeFigureOut">
              <a:rPr lang="en-AU" smtClean="0"/>
              <a:pPr/>
              <a:t>26/03/2014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F3ED-2CCA-455B-9831-C8993F948832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692142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6BE26-DBFF-4419-BFBB-3FA469EE19A6}" type="datetimeFigureOut">
              <a:rPr lang="en-AU" smtClean="0"/>
              <a:pPr/>
              <a:t>26/03/2014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F3ED-2CCA-455B-9831-C8993F948832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1396379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6BE26-DBFF-4419-BFBB-3FA469EE19A6}" type="datetimeFigureOut">
              <a:rPr lang="en-AU" smtClean="0"/>
              <a:pPr/>
              <a:t>26/03/2014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F3ED-2CCA-455B-9831-C8993F948832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2470261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6BE26-DBFF-4419-BFBB-3FA469EE19A6}" type="datetimeFigureOut">
              <a:rPr lang="en-AU" smtClean="0"/>
              <a:pPr/>
              <a:t>26/03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F3ED-2CCA-455B-9831-C8993F948832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11821990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76BE26-DBFF-4419-BFBB-3FA469EE19A6}" type="datetimeFigureOut">
              <a:rPr lang="en-AU" smtClean="0"/>
              <a:pPr/>
              <a:t>26/03/2014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B8F3ED-2CCA-455B-9831-C8993F948832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3728550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76BE26-DBFF-4419-BFBB-3FA469EE19A6}" type="datetimeFigureOut">
              <a:rPr lang="en-AU" smtClean="0"/>
              <a:pPr/>
              <a:t>26/03/2014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B8F3ED-2CCA-455B-9831-C8993F948832}" type="slidenum">
              <a:rPr lang="en-AU" smtClean="0"/>
              <a:pPr/>
              <a:t>‹#›</a:t>
            </a:fld>
            <a:endParaRPr lang="en-AU"/>
          </a:p>
        </p:txBody>
      </p:sp>
    </p:spTree>
    <p:extLst>
      <p:ext uri="{BB962C8B-B14F-4D97-AF65-F5344CB8AC3E}">
        <p14:creationId xmlns="" xmlns:p14="http://schemas.microsoft.com/office/powerpoint/2010/main" val="30260679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5675" t="6890" b="6918"/>
          <a:stretch/>
        </p:blipFill>
        <p:spPr>
          <a:xfrm>
            <a:off x="2270019" y="558842"/>
            <a:ext cx="2816127" cy="2368074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5000" t="6429" b="5952"/>
          <a:stretch/>
        </p:blipFill>
        <p:spPr>
          <a:xfrm>
            <a:off x="2274433" y="3455551"/>
            <a:ext cx="2807298" cy="2382642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4822" t="6429" b="6429"/>
          <a:stretch/>
        </p:blipFill>
        <p:spPr>
          <a:xfrm>
            <a:off x="2272755" y="6308382"/>
            <a:ext cx="2810654" cy="2368074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260648" y="1619769"/>
            <a:ext cx="13272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TaHKT2;1 7AL-1</a:t>
            </a:r>
            <a:endParaRPr lang="en-AU" sz="10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260648" y="4446817"/>
            <a:ext cx="1327276" cy="4001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TaHKT2;1 7BL-1/ TaHKT2;1 7BL-2</a:t>
            </a:r>
            <a:endParaRPr lang="en-AU" sz="10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517232" y="251520"/>
            <a:ext cx="14221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err="1" smtClean="0"/>
              <a:t>Supp</a:t>
            </a:r>
            <a:r>
              <a:rPr lang="en-AU" dirty="0" smtClean="0"/>
              <a:t> info 1</a:t>
            </a:r>
            <a:endParaRPr lang="en-AU" dirty="0"/>
          </a:p>
        </p:txBody>
      </p:sp>
      <p:sp>
        <p:nvSpPr>
          <p:cNvPr id="3" name="TextBox 2"/>
          <p:cNvSpPr txBox="1"/>
          <p:nvPr/>
        </p:nvSpPr>
        <p:spPr>
          <a:xfrm>
            <a:off x="1863262" y="938790"/>
            <a:ext cx="323165" cy="160817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AU" sz="900" dirty="0" err="1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Hydropathy</a:t>
            </a:r>
            <a:r>
              <a:rPr lang="en-AU" sz="9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(kcal/</a:t>
            </a:r>
            <a:r>
              <a:rPr lang="en-AU" sz="900" dirty="0" err="1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mol</a:t>
            </a:r>
            <a:r>
              <a:rPr lang="en-AU" sz="9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)</a:t>
            </a:r>
            <a:endParaRPr lang="en-AU" sz="9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863262" y="3842783"/>
            <a:ext cx="323165" cy="160817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AU" sz="900" dirty="0" err="1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Hydropathy</a:t>
            </a:r>
            <a:r>
              <a:rPr lang="en-AU" sz="9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(kcal/</a:t>
            </a:r>
            <a:r>
              <a:rPr lang="en-AU" sz="900" dirty="0" err="1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mol</a:t>
            </a:r>
            <a:r>
              <a:rPr lang="en-AU" sz="9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)</a:t>
            </a:r>
            <a:endParaRPr lang="en-AU" sz="9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863262" y="6688330"/>
            <a:ext cx="323165" cy="160817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lang="en-AU" sz="900" dirty="0" err="1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Hydropathy</a:t>
            </a:r>
            <a:r>
              <a:rPr lang="en-AU" sz="9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 (kcal/</a:t>
            </a:r>
            <a:r>
              <a:rPr lang="en-AU" sz="900" dirty="0" err="1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mol</a:t>
            </a:r>
            <a:r>
              <a:rPr lang="en-AU" sz="9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)</a:t>
            </a:r>
            <a:endParaRPr lang="en-AU" sz="9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60648" y="7369309"/>
            <a:ext cx="13272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000" dirty="0" smtClean="0">
                <a:latin typeface="Verdana" panose="020B0604030504040204" pitchFamily="34" charset="0"/>
                <a:ea typeface="Verdana" panose="020B0604030504040204" pitchFamily="34" charset="0"/>
                <a:cs typeface="Verdana" panose="020B0604030504040204" pitchFamily="34" charset="0"/>
              </a:rPr>
              <a:t>TaHKT2;1 7AL-1</a:t>
            </a:r>
            <a:endParaRPr lang="en-AU" sz="1000" dirty="0">
              <a:latin typeface="Verdana" panose="020B0604030504040204" pitchFamily="34" charset="0"/>
              <a:ea typeface="Verdana" panose="020B0604030504040204" pitchFamily="34" charset="0"/>
              <a:cs typeface="Verdana" panose="020B060403050404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2561958" y="2987824"/>
            <a:ext cx="22322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900" dirty="0" smtClean="0">
                <a:latin typeface="Verdana" pitchFamily="34" charset="0"/>
              </a:rPr>
              <a:t>Amino acid residue number</a:t>
            </a:r>
            <a:endParaRPr lang="en-AU" sz="900" dirty="0">
              <a:latin typeface="Verdana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561958" y="5868144"/>
            <a:ext cx="22322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900" dirty="0" smtClean="0">
                <a:latin typeface="Verdana" pitchFamily="34" charset="0"/>
              </a:rPr>
              <a:t>Amino acid residue number</a:t>
            </a:r>
            <a:endParaRPr lang="en-AU" sz="900" dirty="0">
              <a:latin typeface="Verdana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561958" y="8748464"/>
            <a:ext cx="22322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900" dirty="0" smtClean="0">
                <a:latin typeface="Verdana" pitchFamily="34" charset="0"/>
              </a:rPr>
              <a:t>Amino acid residue number</a:t>
            </a:r>
            <a:endParaRPr lang="en-AU" sz="900" dirty="0">
              <a:latin typeface="Verdana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23337857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6</TotalTime>
  <Words>36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Francki, Michael</cp:lastModifiedBy>
  <cp:revision>10</cp:revision>
  <dcterms:created xsi:type="dcterms:W3CDTF">2014-02-06T02:07:14Z</dcterms:created>
  <dcterms:modified xsi:type="dcterms:W3CDTF">2014-03-26T07:58:10Z</dcterms:modified>
</cp:coreProperties>
</file>